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7B9F9ED-B76E-418E-A55F-B739836252DB}" v="15" dt="2025-10-17T11:03:45.19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2634" y="-21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dori IKEZAKI" userId="fd67c7cb21f100c9" providerId="LiveId" clId="{3A9434AE-C88A-430D-81D2-E32D4B38066A}"/>
    <pc:docChg chg="undo custSel addSld modSld">
      <pc:chgData name="Midori IKEZAKI" userId="fd67c7cb21f100c9" providerId="LiveId" clId="{3A9434AE-C88A-430D-81D2-E32D4B38066A}" dt="2025-10-17T11:03:49.572" v="295" actId="1076"/>
      <pc:docMkLst>
        <pc:docMk/>
      </pc:docMkLst>
      <pc:sldChg chg="addSp modSp mod">
        <pc:chgData name="Midori IKEZAKI" userId="fd67c7cb21f100c9" providerId="LiveId" clId="{3A9434AE-C88A-430D-81D2-E32D4B38066A}" dt="2025-10-17T10:39:34.996" v="126" actId="1076"/>
        <pc:sldMkLst>
          <pc:docMk/>
          <pc:sldMk cId="3488421163" sldId="256"/>
        </pc:sldMkLst>
        <pc:spChg chg="mod">
          <ac:chgData name="Midori IKEZAKI" userId="fd67c7cb21f100c9" providerId="LiveId" clId="{3A9434AE-C88A-430D-81D2-E32D4B38066A}" dt="2025-10-17T10:37:31.201" v="91" actId="552"/>
          <ac:spMkLst>
            <pc:docMk/>
            <pc:sldMk cId="3488421163" sldId="256"/>
            <ac:spMk id="3" creationId="{8D573505-69E2-F1D2-8E9F-55E752B7BB4B}"/>
          </ac:spMkLst>
        </pc:spChg>
        <pc:spChg chg="mod">
          <ac:chgData name="Midori IKEZAKI" userId="fd67c7cb21f100c9" providerId="LiveId" clId="{3A9434AE-C88A-430D-81D2-E32D4B38066A}" dt="2025-10-17T10:38:06.968" v="113" actId="552"/>
          <ac:spMkLst>
            <pc:docMk/>
            <pc:sldMk cId="3488421163" sldId="256"/>
            <ac:spMk id="5" creationId="{6EB9518A-CAE2-6D0B-7EC5-E9FF94289598}"/>
          </ac:spMkLst>
        </pc:spChg>
        <pc:spChg chg="mod">
          <ac:chgData name="Midori IKEZAKI" userId="fd67c7cb21f100c9" providerId="LiveId" clId="{3A9434AE-C88A-430D-81D2-E32D4B38066A}" dt="2025-10-17T10:38:19.770" v="117" actId="1035"/>
          <ac:spMkLst>
            <pc:docMk/>
            <pc:sldMk cId="3488421163" sldId="256"/>
            <ac:spMk id="7" creationId="{E7A62D8F-19DC-D140-1330-66D07D3A6FE4}"/>
          </ac:spMkLst>
        </pc:spChg>
        <pc:spChg chg="mod">
          <ac:chgData name="Midori IKEZAKI" userId="fd67c7cb21f100c9" providerId="LiveId" clId="{3A9434AE-C88A-430D-81D2-E32D4B38066A}" dt="2025-10-17T10:37:31.201" v="91" actId="552"/>
          <ac:spMkLst>
            <pc:docMk/>
            <pc:sldMk cId="3488421163" sldId="256"/>
            <ac:spMk id="9" creationId="{0A514260-0C84-9B14-9E5C-634DFBD7B2C4}"/>
          </ac:spMkLst>
        </pc:spChg>
        <pc:spChg chg="mod">
          <ac:chgData name="Midori IKEZAKI" userId="fd67c7cb21f100c9" providerId="LiveId" clId="{3A9434AE-C88A-430D-81D2-E32D4B38066A}" dt="2025-10-17T10:38:19.770" v="117" actId="1035"/>
          <ac:spMkLst>
            <pc:docMk/>
            <pc:sldMk cId="3488421163" sldId="256"/>
            <ac:spMk id="11" creationId="{55134CB4-E86D-A59B-85A7-0C48AA7BDEC6}"/>
          </ac:spMkLst>
        </pc:spChg>
        <pc:spChg chg="mod">
          <ac:chgData name="Midori IKEZAKI" userId="fd67c7cb21f100c9" providerId="LiveId" clId="{3A9434AE-C88A-430D-81D2-E32D4B38066A}" dt="2025-10-17T10:39:09.893" v="124" actId="554"/>
          <ac:spMkLst>
            <pc:docMk/>
            <pc:sldMk cId="3488421163" sldId="256"/>
            <ac:spMk id="13" creationId="{E9AFF4E7-D4FF-E0E0-2529-D8F6F66AB7F5}"/>
          </ac:spMkLst>
        </pc:spChg>
        <pc:spChg chg="mod">
          <ac:chgData name="Midori IKEZAKI" userId="fd67c7cb21f100c9" providerId="LiveId" clId="{3A9434AE-C88A-430D-81D2-E32D4B38066A}" dt="2025-10-17T10:39:09.893" v="124" actId="554"/>
          <ac:spMkLst>
            <pc:docMk/>
            <pc:sldMk cId="3488421163" sldId="256"/>
            <ac:spMk id="15" creationId="{0F74D8B5-43C1-0A7F-A091-A3E9F93C7535}"/>
          </ac:spMkLst>
        </pc:spChg>
        <pc:spChg chg="mod">
          <ac:chgData name="Midori IKEZAKI" userId="fd67c7cb21f100c9" providerId="LiveId" clId="{3A9434AE-C88A-430D-81D2-E32D4B38066A}" dt="2025-10-17T10:39:34.996" v="126" actId="1076"/>
          <ac:spMkLst>
            <pc:docMk/>
            <pc:sldMk cId="3488421163" sldId="256"/>
            <ac:spMk id="17" creationId="{C87300B2-D62E-F008-BB10-4F2D6D9FCE15}"/>
          </ac:spMkLst>
        </pc:spChg>
        <pc:spChg chg="add mod">
          <ac:chgData name="Midori IKEZAKI" userId="fd67c7cb21f100c9" providerId="LiveId" clId="{3A9434AE-C88A-430D-81D2-E32D4B38066A}" dt="2025-10-17T10:36:13.248" v="53" actId="1076"/>
          <ac:spMkLst>
            <pc:docMk/>
            <pc:sldMk cId="3488421163" sldId="256"/>
            <ac:spMk id="18" creationId="{08D214F9-BB0B-8D6D-EBE5-9DB824A47BCA}"/>
          </ac:spMkLst>
        </pc:spChg>
        <pc:picChg chg="mod">
          <ac:chgData name="Midori IKEZAKI" userId="fd67c7cb21f100c9" providerId="LiveId" clId="{3A9434AE-C88A-430D-81D2-E32D4B38066A}" dt="2025-10-17T10:38:41.272" v="120" actId="552"/>
          <ac:picMkLst>
            <pc:docMk/>
            <pc:sldMk cId="3488421163" sldId="256"/>
            <ac:picMk id="2" creationId="{BFAA86F0-BCFA-C4E4-F85B-DFCF2C9B6F3F}"/>
          </ac:picMkLst>
        </pc:picChg>
        <pc:picChg chg="mod">
          <ac:chgData name="Midori IKEZAKI" userId="fd67c7cb21f100c9" providerId="LiveId" clId="{3A9434AE-C88A-430D-81D2-E32D4B38066A}" dt="2025-10-17T10:38:06.968" v="113" actId="552"/>
          <ac:picMkLst>
            <pc:docMk/>
            <pc:sldMk cId="3488421163" sldId="256"/>
            <ac:picMk id="4" creationId="{7F1BBEDA-3E35-2FC8-74E7-367E10047078}"/>
          </ac:picMkLst>
        </pc:picChg>
        <pc:picChg chg="mod">
          <ac:chgData name="Midori IKEZAKI" userId="fd67c7cb21f100c9" providerId="LiveId" clId="{3A9434AE-C88A-430D-81D2-E32D4B38066A}" dt="2025-10-17T10:38:41.272" v="120" actId="552"/>
          <ac:picMkLst>
            <pc:docMk/>
            <pc:sldMk cId="3488421163" sldId="256"/>
            <ac:picMk id="6" creationId="{69286FB7-2FAE-74F5-296D-5E907452E33A}"/>
          </ac:picMkLst>
        </pc:picChg>
        <pc:picChg chg="mod">
          <ac:chgData name="Midori IKEZAKI" userId="fd67c7cb21f100c9" providerId="LiveId" clId="{3A9434AE-C88A-430D-81D2-E32D4B38066A}" dt="2025-10-17T10:38:51.276" v="122" actId="1035"/>
          <ac:picMkLst>
            <pc:docMk/>
            <pc:sldMk cId="3488421163" sldId="256"/>
            <ac:picMk id="8" creationId="{002BEEC8-A156-FAAA-F799-BBD0643CCF04}"/>
          </ac:picMkLst>
        </pc:picChg>
        <pc:picChg chg="mod">
          <ac:chgData name="Midori IKEZAKI" userId="fd67c7cb21f100c9" providerId="LiveId" clId="{3A9434AE-C88A-430D-81D2-E32D4B38066A}" dt="2025-10-17T10:38:31.103" v="119" actId="554"/>
          <ac:picMkLst>
            <pc:docMk/>
            <pc:sldMk cId="3488421163" sldId="256"/>
            <ac:picMk id="10" creationId="{7EDC004E-110C-F71D-E2E6-6E8F76AE8FB4}"/>
          </ac:picMkLst>
        </pc:picChg>
        <pc:picChg chg="mod">
          <ac:chgData name="Midori IKEZAKI" userId="fd67c7cb21f100c9" providerId="LiveId" clId="{3A9434AE-C88A-430D-81D2-E32D4B38066A}" dt="2025-10-17T10:39:16.272" v="125" actId="554"/>
          <ac:picMkLst>
            <pc:docMk/>
            <pc:sldMk cId="3488421163" sldId="256"/>
            <ac:picMk id="12" creationId="{064817C6-D0A2-4CB3-31EC-54EDB4626851}"/>
          </ac:picMkLst>
        </pc:picChg>
        <pc:picChg chg="mod">
          <ac:chgData name="Midori IKEZAKI" userId="fd67c7cb21f100c9" providerId="LiveId" clId="{3A9434AE-C88A-430D-81D2-E32D4B38066A}" dt="2025-10-17T10:39:16.272" v="125" actId="554"/>
          <ac:picMkLst>
            <pc:docMk/>
            <pc:sldMk cId="3488421163" sldId="256"/>
            <ac:picMk id="14" creationId="{EAFE8A96-3E07-E156-57FF-22D05EEFBBB8}"/>
          </ac:picMkLst>
        </pc:picChg>
      </pc:sldChg>
      <pc:sldChg chg="addSp delSp modSp add mod">
        <pc:chgData name="Midori IKEZAKI" userId="fd67c7cb21f100c9" providerId="LiveId" clId="{3A9434AE-C88A-430D-81D2-E32D4B38066A}" dt="2025-10-17T11:03:49.572" v="295" actId="1076"/>
        <pc:sldMkLst>
          <pc:docMk/>
          <pc:sldMk cId="1792001685" sldId="257"/>
        </pc:sldMkLst>
        <pc:spChg chg="mod">
          <ac:chgData name="Midori IKEZAKI" userId="fd67c7cb21f100c9" providerId="LiveId" clId="{3A9434AE-C88A-430D-81D2-E32D4B38066A}" dt="2025-10-17T11:02:27.818" v="214" actId="1035"/>
          <ac:spMkLst>
            <pc:docMk/>
            <pc:sldMk cId="1792001685" sldId="257"/>
            <ac:spMk id="2" creationId="{7A74A917-A6C1-CF4A-DF47-16B683C1D3F3}"/>
          </ac:spMkLst>
        </pc:spChg>
        <pc:spChg chg="mod">
          <ac:chgData name="Midori IKEZAKI" userId="fd67c7cb21f100c9" providerId="LiveId" clId="{3A9434AE-C88A-430D-81D2-E32D4B38066A}" dt="2025-10-17T11:02:47.298" v="233" actId="20577"/>
          <ac:spMkLst>
            <pc:docMk/>
            <pc:sldMk cId="1792001685" sldId="257"/>
            <ac:spMk id="3" creationId="{8D573505-69E2-F1D2-8E9F-55E752B7BB4B}"/>
          </ac:spMkLst>
        </pc:spChg>
        <pc:spChg chg="del">
          <ac:chgData name="Midori IKEZAKI" userId="fd67c7cb21f100c9" providerId="LiveId" clId="{3A9434AE-C88A-430D-81D2-E32D4B38066A}" dt="2025-10-17T10:41:00.256" v="132" actId="478"/>
          <ac:spMkLst>
            <pc:docMk/>
            <pc:sldMk cId="1792001685" sldId="257"/>
            <ac:spMk id="4" creationId="{59D9EDBA-5EA3-54A4-59D7-9C16BF92E1FA}"/>
          </ac:spMkLst>
        </pc:spChg>
        <pc:spChg chg="mod">
          <ac:chgData name="Midori IKEZAKI" userId="fd67c7cb21f100c9" providerId="LiveId" clId="{3A9434AE-C88A-430D-81D2-E32D4B38066A}" dt="2025-10-17T11:02:27.818" v="214" actId="1035"/>
          <ac:spMkLst>
            <pc:docMk/>
            <pc:sldMk cId="1792001685" sldId="257"/>
            <ac:spMk id="9" creationId="{AC938C26-F9D2-0962-5FBB-E501C086341A}"/>
          </ac:spMkLst>
        </pc:spChg>
        <pc:spChg chg="del">
          <ac:chgData name="Midori IKEZAKI" userId="fd67c7cb21f100c9" providerId="LiveId" clId="{3A9434AE-C88A-430D-81D2-E32D4B38066A}" dt="2025-10-17T10:41:00.256" v="132" actId="478"/>
          <ac:spMkLst>
            <pc:docMk/>
            <pc:sldMk cId="1792001685" sldId="257"/>
            <ac:spMk id="10" creationId="{D22ACC36-B1E4-AFA2-D4CB-DA7229D832C6}"/>
          </ac:spMkLst>
        </pc:spChg>
        <pc:spChg chg="add mod">
          <ac:chgData name="Midori IKEZAKI" userId="fd67c7cb21f100c9" providerId="LiveId" clId="{3A9434AE-C88A-430D-81D2-E32D4B38066A}" dt="2025-10-17T11:02:27.818" v="214" actId="1035"/>
          <ac:spMkLst>
            <pc:docMk/>
            <pc:sldMk cId="1792001685" sldId="257"/>
            <ac:spMk id="11" creationId="{06719793-D81E-24AA-EFCD-1251A9BFACA4}"/>
          </ac:spMkLst>
        </pc:spChg>
        <pc:spChg chg="mod">
          <ac:chgData name="Midori IKEZAKI" userId="fd67c7cb21f100c9" providerId="LiveId" clId="{3A9434AE-C88A-430D-81D2-E32D4B38066A}" dt="2025-10-17T11:03:01.399" v="245" actId="20577"/>
          <ac:spMkLst>
            <pc:docMk/>
            <pc:sldMk cId="1792001685" sldId="257"/>
            <ac:spMk id="13" creationId="{E9AFF4E7-D4FF-E0E0-2529-D8F6F66AB7F5}"/>
          </ac:spMkLst>
        </pc:spChg>
        <pc:spChg chg="mod">
          <ac:chgData name="Midori IKEZAKI" userId="fd67c7cb21f100c9" providerId="LiveId" clId="{3A9434AE-C88A-430D-81D2-E32D4B38066A}" dt="2025-10-17T11:02:27.818" v="214" actId="1035"/>
          <ac:spMkLst>
            <pc:docMk/>
            <pc:sldMk cId="1792001685" sldId="257"/>
            <ac:spMk id="15" creationId="{9034458F-91A4-8DE8-F4F3-52480CB575D5}"/>
          </ac:spMkLst>
        </pc:spChg>
        <pc:spChg chg="del">
          <ac:chgData name="Midori IKEZAKI" userId="fd67c7cb21f100c9" providerId="LiveId" clId="{3A9434AE-C88A-430D-81D2-E32D4B38066A}" dt="2025-10-17T10:40:04.818" v="128" actId="478"/>
          <ac:spMkLst>
            <pc:docMk/>
            <pc:sldMk cId="1792001685" sldId="257"/>
            <ac:spMk id="16" creationId="{DA6DEDFE-923D-1023-05B1-8BCD91B1029E}"/>
          </ac:spMkLst>
        </pc:spChg>
        <pc:spChg chg="mod ord">
          <ac:chgData name="Midori IKEZAKI" userId="fd67c7cb21f100c9" providerId="LiveId" clId="{3A9434AE-C88A-430D-81D2-E32D4B38066A}" dt="2025-10-17T11:03:12.926" v="250" actId="1036"/>
          <ac:spMkLst>
            <pc:docMk/>
            <pc:sldMk cId="1792001685" sldId="257"/>
            <ac:spMk id="17" creationId="{C87300B2-D62E-F008-BB10-4F2D6D9FCE15}"/>
          </ac:spMkLst>
        </pc:spChg>
        <pc:spChg chg="mod">
          <ac:chgData name="Midori IKEZAKI" userId="fd67c7cb21f100c9" providerId="LiveId" clId="{3A9434AE-C88A-430D-81D2-E32D4B38066A}" dt="2025-10-17T10:40:56.271" v="131" actId="20577"/>
          <ac:spMkLst>
            <pc:docMk/>
            <pc:sldMk cId="1792001685" sldId="257"/>
            <ac:spMk id="18" creationId="{134CEBAE-4CAA-CD76-CA8F-1CFAC9266987}"/>
          </ac:spMkLst>
        </pc:spChg>
        <pc:spChg chg="mod">
          <ac:chgData name="Midori IKEZAKI" userId="fd67c7cb21f100c9" providerId="LiveId" clId="{3A9434AE-C88A-430D-81D2-E32D4B38066A}" dt="2025-10-17T11:02:27.818" v="214" actId="1035"/>
          <ac:spMkLst>
            <pc:docMk/>
            <pc:sldMk cId="1792001685" sldId="257"/>
            <ac:spMk id="19" creationId="{B7D779B6-34F7-6214-92D5-8D51988348C3}"/>
          </ac:spMkLst>
        </pc:spChg>
        <pc:spChg chg="mod">
          <ac:chgData name="Midori IKEZAKI" userId="fd67c7cb21f100c9" providerId="LiveId" clId="{3A9434AE-C88A-430D-81D2-E32D4B38066A}" dt="2025-10-17T11:02:27.818" v="214" actId="1035"/>
          <ac:spMkLst>
            <pc:docMk/>
            <pc:sldMk cId="1792001685" sldId="257"/>
            <ac:spMk id="20" creationId="{2019E36E-07B8-5F10-1C1E-E84C5D1D620D}"/>
          </ac:spMkLst>
        </pc:spChg>
        <pc:spChg chg="del mod">
          <ac:chgData name="Midori IKEZAKI" userId="fd67c7cb21f100c9" providerId="LiveId" clId="{3A9434AE-C88A-430D-81D2-E32D4B38066A}" dt="2025-10-17T11:03:17.394" v="251" actId="478"/>
          <ac:spMkLst>
            <pc:docMk/>
            <pc:sldMk cId="1792001685" sldId="257"/>
            <ac:spMk id="26" creationId="{50C7B2F7-0C9D-72E3-0414-26EF9523BC6E}"/>
          </ac:spMkLst>
        </pc:spChg>
        <pc:spChg chg="mod ord">
          <ac:chgData name="Midori IKEZAKI" userId="fd67c7cb21f100c9" providerId="LiveId" clId="{3A9434AE-C88A-430D-81D2-E32D4B38066A}" dt="2025-10-17T11:02:27.818" v="214" actId="1035"/>
          <ac:spMkLst>
            <pc:docMk/>
            <pc:sldMk cId="1792001685" sldId="257"/>
            <ac:spMk id="28" creationId="{1999D967-328B-C544-88B7-505560A8D68C}"/>
          </ac:spMkLst>
        </pc:spChg>
        <pc:spChg chg="add mod">
          <ac:chgData name="Midori IKEZAKI" userId="fd67c7cb21f100c9" providerId="LiveId" clId="{3A9434AE-C88A-430D-81D2-E32D4B38066A}" dt="2025-10-17T11:03:43.311" v="293" actId="1076"/>
          <ac:spMkLst>
            <pc:docMk/>
            <pc:sldMk cId="1792001685" sldId="257"/>
            <ac:spMk id="29" creationId="{65FA6047-C55A-773D-EB38-9EA71FAE8258}"/>
          </ac:spMkLst>
        </pc:spChg>
        <pc:spChg chg="add mod">
          <ac:chgData name="Midori IKEZAKI" userId="fd67c7cb21f100c9" providerId="LiveId" clId="{3A9434AE-C88A-430D-81D2-E32D4B38066A}" dt="2025-10-17T11:03:49.572" v="295" actId="1076"/>
          <ac:spMkLst>
            <pc:docMk/>
            <pc:sldMk cId="1792001685" sldId="257"/>
            <ac:spMk id="30" creationId="{DE94C386-02AB-EB16-3BF0-ADB5ADDCA159}"/>
          </ac:spMkLst>
        </pc:spChg>
        <pc:spChg chg="mod">
          <ac:chgData name="Midori IKEZAKI" userId="fd67c7cb21f100c9" providerId="LiveId" clId="{3A9434AE-C88A-430D-81D2-E32D4B38066A}" dt="2025-10-17T11:02:27.818" v="214" actId="1035"/>
          <ac:spMkLst>
            <pc:docMk/>
            <pc:sldMk cId="1792001685" sldId="257"/>
            <ac:spMk id="31" creationId="{FFFFD69F-7980-237F-7E33-2ADD480E6460}"/>
          </ac:spMkLst>
        </pc:spChg>
        <pc:spChg chg="del">
          <ac:chgData name="Midori IKEZAKI" userId="fd67c7cb21f100c9" providerId="LiveId" clId="{3A9434AE-C88A-430D-81D2-E32D4B38066A}" dt="2025-10-17T10:41:16.071" v="141" actId="478"/>
          <ac:spMkLst>
            <pc:docMk/>
            <pc:sldMk cId="1792001685" sldId="257"/>
            <ac:spMk id="33" creationId="{ED3EA172-ADEF-AB80-9F06-C22FA24A9B47}"/>
          </ac:spMkLst>
        </pc:spChg>
        <pc:spChg chg="del">
          <ac:chgData name="Midori IKEZAKI" userId="fd67c7cb21f100c9" providerId="LiveId" clId="{3A9434AE-C88A-430D-81D2-E32D4B38066A}" dt="2025-10-17T10:41:16.071" v="141" actId="478"/>
          <ac:spMkLst>
            <pc:docMk/>
            <pc:sldMk cId="1792001685" sldId="257"/>
            <ac:spMk id="34" creationId="{F32A7B63-3E9F-F7D3-F9F9-E3B4941A3B8E}"/>
          </ac:spMkLst>
        </pc:spChg>
        <pc:spChg chg="del">
          <ac:chgData name="Midori IKEZAKI" userId="fd67c7cb21f100c9" providerId="LiveId" clId="{3A9434AE-C88A-430D-81D2-E32D4B38066A}" dt="2025-10-17T10:41:16.071" v="141" actId="478"/>
          <ac:spMkLst>
            <pc:docMk/>
            <pc:sldMk cId="1792001685" sldId="257"/>
            <ac:spMk id="40" creationId="{46ECB76F-6EFB-1DF3-4521-20507F595A65}"/>
          </ac:spMkLst>
        </pc:spChg>
        <pc:spChg chg="del">
          <ac:chgData name="Midori IKEZAKI" userId="fd67c7cb21f100c9" providerId="LiveId" clId="{3A9434AE-C88A-430D-81D2-E32D4B38066A}" dt="2025-10-17T10:41:20.380" v="142" actId="478"/>
          <ac:spMkLst>
            <pc:docMk/>
            <pc:sldMk cId="1792001685" sldId="257"/>
            <ac:spMk id="41" creationId="{DF77C6D6-BA22-6A56-4747-17BDB59A917D}"/>
          </ac:spMkLst>
        </pc:spChg>
        <pc:spChg chg="del">
          <ac:chgData name="Midori IKEZAKI" userId="fd67c7cb21f100c9" providerId="LiveId" clId="{3A9434AE-C88A-430D-81D2-E32D4B38066A}" dt="2025-10-17T10:41:20.380" v="142" actId="478"/>
          <ac:spMkLst>
            <pc:docMk/>
            <pc:sldMk cId="1792001685" sldId="257"/>
            <ac:spMk id="43" creationId="{84774F78-CEF7-5435-5325-272A9C7CE226}"/>
          </ac:spMkLst>
        </pc:spChg>
        <pc:spChg chg="del">
          <ac:chgData name="Midori IKEZAKI" userId="fd67c7cb21f100c9" providerId="LiveId" clId="{3A9434AE-C88A-430D-81D2-E32D4B38066A}" dt="2025-10-17T10:41:16.071" v="141" actId="478"/>
          <ac:spMkLst>
            <pc:docMk/>
            <pc:sldMk cId="1792001685" sldId="257"/>
            <ac:spMk id="44" creationId="{370CEB9E-059D-D090-0CF7-623F1CFDFD47}"/>
          </ac:spMkLst>
        </pc:spChg>
        <pc:spChg chg="del">
          <ac:chgData name="Midori IKEZAKI" userId="fd67c7cb21f100c9" providerId="LiveId" clId="{3A9434AE-C88A-430D-81D2-E32D4B38066A}" dt="2025-10-17T10:41:16.071" v="141" actId="478"/>
          <ac:spMkLst>
            <pc:docMk/>
            <pc:sldMk cId="1792001685" sldId="257"/>
            <ac:spMk id="46" creationId="{051FA824-9FCE-0A1C-1F6F-4F46D7161416}"/>
          </ac:spMkLst>
        </pc:spChg>
        <pc:picChg chg="add mod">
          <ac:chgData name="Midori IKEZAKI" userId="fd67c7cb21f100c9" providerId="LiveId" clId="{3A9434AE-C88A-430D-81D2-E32D4B38066A}" dt="2025-10-17T10:45:37.664" v="178" actId="208"/>
          <ac:picMkLst>
            <pc:docMk/>
            <pc:sldMk cId="1792001685" sldId="257"/>
            <ac:picMk id="6" creationId="{3284BB65-D0CD-71AF-E764-52669A440CB3}"/>
          </ac:picMkLst>
        </pc:picChg>
        <pc:picChg chg="add mod">
          <ac:chgData name="Midori IKEZAKI" userId="fd67c7cb21f100c9" providerId="LiveId" clId="{3A9434AE-C88A-430D-81D2-E32D4B38066A}" dt="2025-10-17T11:01:52.681" v="202" actId="552"/>
          <ac:picMkLst>
            <pc:docMk/>
            <pc:sldMk cId="1792001685" sldId="257"/>
            <ac:picMk id="8" creationId="{32F7DC2A-645B-713B-9C5C-22AECD7DAF56}"/>
          </ac:picMkLst>
        </pc:picChg>
        <pc:picChg chg="add del mod">
          <ac:chgData name="Midori IKEZAKI" userId="fd67c7cb21f100c9" providerId="LiveId" clId="{3A9434AE-C88A-430D-81D2-E32D4B38066A}" dt="2025-10-17T10:50:15.197" v="184" actId="478"/>
          <ac:picMkLst>
            <pc:docMk/>
            <pc:sldMk cId="1792001685" sldId="257"/>
            <ac:picMk id="14" creationId="{DDA30748-65EF-DF99-B5B4-2F6FBA30A703}"/>
          </ac:picMkLst>
        </pc:picChg>
        <pc:picChg chg="add mod">
          <ac:chgData name="Midori IKEZAKI" userId="fd67c7cb21f100c9" providerId="LiveId" clId="{3A9434AE-C88A-430D-81D2-E32D4B38066A}" dt="2025-10-17T11:02:06.330" v="206" actId="552"/>
          <ac:picMkLst>
            <pc:docMk/>
            <pc:sldMk cId="1792001685" sldId="257"/>
            <ac:picMk id="22" creationId="{A314A290-6632-7C01-AFFD-99FF84A51EA9}"/>
          </ac:picMkLst>
        </pc:picChg>
        <pc:picChg chg="add mod">
          <ac:chgData name="Midori IKEZAKI" userId="fd67c7cb21f100c9" providerId="LiveId" clId="{3A9434AE-C88A-430D-81D2-E32D4B38066A}" dt="2025-10-17T11:01:52.681" v="202" actId="552"/>
          <ac:picMkLst>
            <pc:docMk/>
            <pc:sldMk cId="1792001685" sldId="257"/>
            <ac:picMk id="24" creationId="{AEFF8D29-D010-C099-FF0F-E9128CA7321B}"/>
          </ac:picMkLst>
        </pc:picChg>
        <pc:picChg chg="add mod">
          <ac:chgData name="Midori IKEZAKI" userId="fd67c7cb21f100c9" providerId="LiveId" clId="{3A9434AE-C88A-430D-81D2-E32D4B38066A}" dt="2025-10-17T11:02:06.330" v="206" actId="552"/>
          <ac:picMkLst>
            <pc:docMk/>
            <pc:sldMk cId="1792001685" sldId="257"/>
            <ac:picMk id="27" creationId="{C0283208-EBBD-A1C9-1848-62B43B82EBAB}"/>
          </ac:picMkLst>
        </pc:picChg>
        <pc:picChg chg="del mod">
          <ac:chgData name="Midori IKEZAKI" userId="fd67c7cb21f100c9" providerId="LiveId" clId="{3A9434AE-C88A-430D-81D2-E32D4B38066A}" dt="2025-10-17T11:01:25.088" v="196" actId="478"/>
          <ac:picMkLst>
            <pc:docMk/>
            <pc:sldMk cId="1792001685" sldId="257"/>
            <ac:picMk id="48" creationId="{D1E0E5BC-26AA-E652-6E5C-7A969D4574FD}"/>
          </ac:picMkLst>
        </pc:picChg>
        <pc:picChg chg="del mod">
          <ac:chgData name="Midori IKEZAKI" userId="fd67c7cb21f100c9" providerId="LiveId" clId="{3A9434AE-C88A-430D-81D2-E32D4B38066A}" dt="2025-10-17T11:02:01.701" v="205" actId="478"/>
          <ac:picMkLst>
            <pc:docMk/>
            <pc:sldMk cId="1792001685" sldId="257"/>
            <ac:picMk id="50" creationId="{D69C273B-FAE8-FB7B-0595-E2666FF852DE}"/>
          </ac:picMkLst>
        </pc:picChg>
        <pc:picChg chg="del mod">
          <ac:chgData name="Midori IKEZAKI" userId="fd67c7cb21f100c9" providerId="LiveId" clId="{3A9434AE-C88A-430D-81D2-E32D4B38066A}" dt="2025-10-17T11:01:47.519" v="201" actId="478"/>
          <ac:picMkLst>
            <pc:docMk/>
            <pc:sldMk cId="1792001685" sldId="257"/>
            <ac:picMk id="56" creationId="{48EDC879-D599-A6ED-224D-D65622BF653E}"/>
          </ac:picMkLst>
        </pc:picChg>
        <pc:picChg chg="del">
          <ac:chgData name="Midori IKEZAKI" userId="fd67c7cb21f100c9" providerId="LiveId" clId="{3A9434AE-C88A-430D-81D2-E32D4B38066A}" dt="2025-10-17T10:41:00.256" v="132" actId="478"/>
          <ac:picMkLst>
            <pc:docMk/>
            <pc:sldMk cId="1792001685" sldId="257"/>
            <ac:picMk id="62" creationId="{78CDF0C5-05D2-2D8C-76D3-C68007E06609}"/>
          </ac:picMkLst>
        </pc:picChg>
        <pc:picChg chg="del mod">
          <ac:chgData name="Midori IKEZAKI" userId="fd67c7cb21f100c9" providerId="LiveId" clId="{3A9434AE-C88A-430D-81D2-E32D4B38066A}" dt="2025-10-17T10:45:15.739" v="173" actId="478"/>
          <ac:picMkLst>
            <pc:docMk/>
            <pc:sldMk cId="1792001685" sldId="257"/>
            <ac:picMk id="64" creationId="{4A04064B-F12E-31BE-A2CA-76D478F851B0}"/>
          </ac:picMkLst>
        </pc:picChg>
        <pc:picChg chg="del">
          <ac:chgData name="Midori IKEZAKI" userId="fd67c7cb21f100c9" providerId="LiveId" clId="{3A9434AE-C88A-430D-81D2-E32D4B38066A}" dt="2025-10-17T10:41:16.071" v="141" actId="478"/>
          <ac:picMkLst>
            <pc:docMk/>
            <pc:sldMk cId="1792001685" sldId="257"/>
            <ac:picMk id="71" creationId="{A8A10F79-B1E2-BC13-7D4B-89B342D00FB2}"/>
          </ac:picMkLst>
        </pc:picChg>
        <pc:picChg chg="del mod">
          <ac:chgData name="Midori IKEZAKI" userId="fd67c7cb21f100c9" providerId="LiveId" clId="{3A9434AE-C88A-430D-81D2-E32D4B38066A}" dt="2025-10-17T10:45:28.599" v="176" actId="478"/>
          <ac:picMkLst>
            <pc:docMk/>
            <pc:sldMk cId="1792001685" sldId="257"/>
            <ac:picMk id="74" creationId="{CAA37687-B3DF-14AF-DB92-D6446262DEDE}"/>
          </ac:picMkLst>
        </pc:picChg>
        <pc:picChg chg="del">
          <ac:chgData name="Midori IKEZAKI" userId="fd67c7cb21f100c9" providerId="LiveId" clId="{3A9434AE-C88A-430D-81D2-E32D4B38066A}" dt="2025-10-17T10:41:16.071" v="141" actId="478"/>
          <ac:picMkLst>
            <pc:docMk/>
            <pc:sldMk cId="1792001685" sldId="257"/>
            <ac:picMk id="78" creationId="{F1C851E2-BAE6-6F45-A2AA-0BFE9D8BBA06}"/>
          </ac:picMkLst>
        </pc:picChg>
        <pc:picChg chg="del">
          <ac:chgData name="Midori IKEZAKI" userId="fd67c7cb21f100c9" providerId="LiveId" clId="{3A9434AE-C88A-430D-81D2-E32D4B38066A}" dt="2025-10-17T10:41:20.380" v="142" actId="478"/>
          <ac:picMkLst>
            <pc:docMk/>
            <pc:sldMk cId="1792001685" sldId="257"/>
            <ac:picMk id="80" creationId="{D98F22AF-4FA3-194C-7095-AAD5086E29BD}"/>
          </ac:picMkLst>
        </pc:picChg>
        <pc:picChg chg="del">
          <ac:chgData name="Midori IKEZAKI" userId="fd67c7cb21f100c9" providerId="LiveId" clId="{3A9434AE-C88A-430D-81D2-E32D4B38066A}" dt="2025-10-17T10:41:16.071" v="141" actId="478"/>
          <ac:picMkLst>
            <pc:docMk/>
            <pc:sldMk cId="1792001685" sldId="257"/>
            <ac:picMk id="82" creationId="{1E4D022A-8E55-EEBC-E903-62D11209598D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227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3967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172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1194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3322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153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683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8353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972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103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413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2581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"/><Relationship Id="rId5" Type="http://schemas.openxmlformats.org/officeDocument/2006/relationships/image" Target="../media/image11.tif"/><Relationship Id="rId4" Type="http://schemas.openxmlformats.org/officeDocument/2006/relationships/image" Target="../media/image1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BFAA86F0-BCFA-C4E4-F85B-DFCF2C9B6F3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9" t="-54" r="-91" b="56"/>
          <a:stretch>
            <a:fillRect/>
          </a:stretch>
        </p:blipFill>
        <p:spPr>
          <a:xfrm>
            <a:off x="360000" y="1361607"/>
            <a:ext cx="2314646" cy="173431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D573505-69E2-F1D2-8E9F-55E752B7BB4B}"/>
              </a:ext>
            </a:extLst>
          </p:cNvPr>
          <p:cNvSpPr txBox="1"/>
          <p:nvPr/>
        </p:nvSpPr>
        <p:spPr>
          <a:xfrm>
            <a:off x="360000" y="1080000"/>
            <a:ext cx="1530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CG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7F1BBEDA-3E35-2FC8-74E7-367E1004707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/>
          <a:stretch>
            <a:fillRect/>
          </a:stretch>
        </p:blipFill>
        <p:spPr>
          <a:xfrm>
            <a:off x="3597501" y="1361607"/>
            <a:ext cx="2518483" cy="140940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EB9518A-CAE2-6D0B-7EC5-E9FF94289598}"/>
              </a:ext>
            </a:extLst>
          </p:cNvPr>
          <p:cNvSpPr txBox="1"/>
          <p:nvPr/>
        </p:nvSpPr>
        <p:spPr>
          <a:xfrm>
            <a:off x="3597501" y="1080000"/>
            <a:ext cx="1530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AP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69286FB7-2FAE-74F5-296D-5E907452E33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/>
          <a:stretch>
            <a:fillRect/>
          </a:stretch>
        </p:blipFill>
        <p:spPr>
          <a:xfrm>
            <a:off x="360000" y="3419872"/>
            <a:ext cx="1865144" cy="1201176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7A62D8F-19DC-D140-1330-66D07D3A6FE4}"/>
              </a:ext>
            </a:extLst>
          </p:cNvPr>
          <p:cNvSpPr txBox="1"/>
          <p:nvPr/>
        </p:nvSpPr>
        <p:spPr>
          <a:xfrm>
            <a:off x="360000" y="3131840"/>
            <a:ext cx="1530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A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Lysat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002BEEC8-A156-FAAA-F799-BBD0643CCF0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6795" t="-19040" r="6795" b="19040"/>
          <a:stretch>
            <a:fillRect/>
          </a:stretch>
        </p:blipFill>
        <p:spPr>
          <a:xfrm>
            <a:off x="360000" y="4932040"/>
            <a:ext cx="2160572" cy="121705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A514260-0C84-9B14-9E5C-634DFBD7B2C4}"/>
              </a:ext>
            </a:extLst>
          </p:cNvPr>
          <p:cNvSpPr txBox="1"/>
          <p:nvPr/>
        </p:nvSpPr>
        <p:spPr>
          <a:xfrm>
            <a:off x="360000" y="4673667"/>
            <a:ext cx="1530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7EDC004E-110C-F71D-E2E6-6E8F76AE8FB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3805" t="-556" r="3805" b="556"/>
          <a:stretch>
            <a:fillRect/>
          </a:stretch>
        </p:blipFill>
        <p:spPr>
          <a:xfrm>
            <a:off x="3597501" y="3419872"/>
            <a:ext cx="1865144" cy="111080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5134CB4-E86D-A59B-85A7-0C48AA7BDEC6}"/>
              </a:ext>
            </a:extLst>
          </p:cNvPr>
          <p:cNvSpPr txBox="1"/>
          <p:nvPr/>
        </p:nvSpPr>
        <p:spPr>
          <a:xfrm>
            <a:off x="3597501" y="3131840"/>
            <a:ext cx="1530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BACE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064817C6-D0A2-4CB3-31EC-54EDB462685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/>
          <a:stretch>
            <a:fillRect/>
          </a:stretch>
        </p:blipFill>
        <p:spPr>
          <a:xfrm>
            <a:off x="360000" y="7119997"/>
            <a:ext cx="2851012" cy="169190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9AFF4E7-D4FF-E0E0-2529-D8F6F66AB7F5}"/>
              </a:ext>
            </a:extLst>
          </p:cNvPr>
          <p:cNvSpPr txBox="1"/>
          <p:nvPr/>
        </p:nvSpPr>
        <p:spPr>
          <a:xfrm>
            <a:off x="360000" y="6804248"/>
            <a:ext cx="1530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CG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edium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EAFE8A96-3E07-E156-57FF-22D05EEFBBB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/>
          <a:stretch>
            <a:fillRect/>
          </a:stretch>
        </p:blipFill>
        <p:spPr>
          <a:xfrm>
            <a:off x="3597501" y="7119997"/>
            <a:ext cx="2742941" cy="1645408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F74D8B5-43C1-0A7F-A091-A3E9F93C7535}"/>
              </a:ext>
            </a:extLst>
          </p:cNvPr>
          <p:cNvSpPr txBox="1"/>
          <p:nvPr/>
        </p:nvSpPr>
        <p:spPr>
          <a:xfrm>
            <a:off x="3597501" y="6804248"/>
            <a:ext cx="1530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A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edium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A6DEDFE-923D-1023-05B1-8BCD91B1029E}"/>
              </a:ext>
            </a:extLst>
          </p:cNvPr>
          <p:cNvSpPr txBox="1"/>
          <p:nvPr/>
        </p:nvSpPr>
        <p:spPr>
          <a:xfrm>
            <a:off x="340709" y="243486"/>
            <a:ext cx="537129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We saved the amounts of primary CTB samples for Western blotting. </a:t>
            </a:r>
            <a:r>
              <a:rPr lang="en-US" altLang="ja-JP" sz="1100" dirty="0"/>
              <a:t>Thus, we cut the membranes based on the molecular weights of the target proteins.</a:t>
            </a:r>
            <a:r>
              <a:rPr kumimoji="1" lang="en-US" altLang="ja-JP" sz="1100" dirty="0"/>
              <a:t> </a:t>
            </a:r>
            <a:endParaRPr kumimoji="1" lang="ja-JP" altLang="en-US" sz="1100" dirty="0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C87300B2-D62E-F008-BB10-4F2D6D9FCE15}"/>
              </a:ext>
            </a:extLst>
          </p:cNvPr>
          <p:cNvSpPr/>
          <p:nvPr/>
        </p:nvSpPr>
        <p:spPr>
          <a:xfrm>
            <a:off x="4651801" y="2277759"/>
            <a:ext cx="810844" cy="144016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8D214F9-BB0B-8D6D-EBE5-9DB824A47BCA}"/>
              </a:ext>
            </a:extLst>
          </p:cNvPr>
          <p:cNvSpPr txBox="1"/>
          <p:nvPr/>
        </p:nvSpPr>
        <p:spPr>
          <a:xfrm>
            <a:off x="180000" y="72000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84211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D573505-69E2-F1D2-8E9F-55E752B7BB4B}"/>
              </a:ext>
            </a:extLst>
          </p:cNvPr>
          <p:cNvSpPr txBox="1"/>
          <p:nvPr/>
        </p:nvSpPr>
        <p:spPr>
          <a:xfrm>
            <a:off x="360000" y="920812"/>
            <a:ext cx="15408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CG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edium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Short exposure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9AFF4E7-D4FF-E0E0-2529-D8F6F66AB7F5}"/>
              </a:ext>
            </a:extLst>
          </p:cNvPr>
          <p:cNvSpPr txBox="1"/>
          <p:nvPr/>
        </p:nvSpPr>
        <p:spPr>
          <a:xfrm>
            <a:off x="2520000" y="902904"/>
            <a:ext cx="13003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hCG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Long exposure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34CEBAE-4CAA-CD76-CA8F-1CFAC9266987}"/>
              </a:ext>
            </a:extLst>
          </p:cNvPr>
          <p:cNvSpPr txBox="1"/>
          <p:nvPr/>
        </p:nvSpPr>
        <p:spPr>
          <a:xfrm>
            <a:off x="180000" y="67973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A74A917-A6C1-CF4A-DF47-16B683C1D3F3}"/>
              </a:ext>
            </a:extLst>
          </p:cNvPr>
          <p:cNvSpPr txBox="1"/>
          <p:nvPr/>
        </p:nvSpPr>
        <p:spPr>
          <a:xfrm>
            <a:off x="363173" y="2951472"/>
            <a:ext cx="978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034458F-91A4-8DE8-F4F3-52480CB575D5}"/>
              </a:ext>
            </a:extLst>
          </p:cNvPr>
          <p:cNvSpPr txBox="1"/>
          <p:nvPr/>
        </p:nvSpPr>
        <p:spPr>
          <a:xfrm>
            <a:off x="363800" y="5020483"/>
            <a:ext cx="1217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Syncytin-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7D779B6-34F7-6214-92D5-8D51988348C3}"/>
              </a:ext>
            </a:extLst>
          </p:cNvPr>
          <p:cNvSpPr txBox="1"/>
          <p:nvPr/>
        </p:nvSpPr>
        <p:spPr>
          <a:xfrm>
            <a:off x="2523800" y="5002575"/>
            <a:ext cx="978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019E36E-07B8-5F10-1C1E-E84C5D1D620D}"/>
              </a:ext>
            </a:extLst>
          </p:cNvPr>
          <p:cNvSpPr txBox="1"/>
          <p:nvPr/>
        </p:nvSpPr>
        <p:spPr>
          <a:xfrm>
            <a:off x="183800" y="477940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FFFFD69F-7980-237F-7E33-2ADD480E6460}"/>
              </a:ext>
            </a:extLst>
          </p:cNvPr>
          <p:cNvSpPr/>
          <p:nvPr/>
        </p:nvSpPr>
        <p:spPr>
          <a:xfrm>
            <a:off x="3346125" y="5910228"/>
            <a:ext cx="188856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AC938C26-F9D2-0962-5FBB-E501C086341A}"/>
              </a:ext>
            </a:extLst>
          </p:cNvPr>
          <p:cNvSpPr/>
          <p:nvPr/>
        </p:nvSpPr>
        <p:spPr>
          <a:xfrm>
            <a:off x="1052736" y="3846386"/>
            <a:ext cx="288000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284BB65-D0CD-71AF-E764-52669A440C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173" y="5319405"/>
            <a:ext cx="2066400" cy="1543862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32F7DC2A-645B-713B-9C5C-22AECD7DAF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23173" y="5319405"/>
            <a:ext cx="2066400" cy="1543862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1999D967-328B-C544-88B7-505560A8D68C}"/>
              </a:ext>
            </a:extLst>
          </p:cNvPr>
          <p:cNvSpPr/>
          <p:nvPr/>
        </p:nvSpPr>
        <p:spPr>
          <a:xfrm>
            <a:off x="1396373" y="6023849"/>
            <a:ext cx="301942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06719793-D81E-24AA-EFCD-1251A9BFACA4}"/>
              </a:ext>
            </a:extLst>
          </p:cNvPr>
          <p:cNvSpPr/>
          <p:nvPr/>
        </p:nvSpPr>
        <p:spPr>
          <a:xfrm>
            <a:off x="3556487" y="6158822"/>
            <a:ext cx="301942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id="{A314A290-6632-7C01-AFFD-99FF84A51EA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3173" y="1403648"/>
            <a:ext cx="2066400" cy="1543862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AEFF8D29-D010-C099-FF0F-E9128CA732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23173" y="1403648"/>
            <a:ext cx="2066400" cy="1543862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C0283208-EBBD-A1C9-1848-62B43B82EBA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3173" y="3250394"/>
            <a:ext cx="2066400" cy="1543862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C87300B2-D62E-F008-BB10-4F2D6D9FCE15}"/>
              </a:ext>
            </a:extLst>
          </p:cNvPr>
          <p:cNvSpPr/>
          <p:nvPr/>
        </p:nvSpPr>
        <p:spPr>
          <a:xfrm>
            <a:off x="1124776" y="2060763"/>
            <a:ext cx="288000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65FA6047-C55A-773D-EB38-9EA71FAE8258}"/>
              </a:ext>
            </a:extLst>
          </p:cNvPr>
          <p:cNvSpPr/>
          <p:nvPr/>
        </p:nvSpPr>
        <p:spPr>
          <a:xfrm>
            <a:off x="3820356" y="2058495"/>
            <a:ext cx="288000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DE94C386-02AB-EB16-3BF0-ADB5ADDCA159}"/>
              </a:ext>
            </a:extLst>
          </p:cNvPr>
          <p:cNvSpPr/>
          <p:nvPr/>
        </p:nvSpPr>
        <p:spPr>
          <a:xfrm>
            <a:off x="1403344" y="3711413"/>
            <a:ext cx="288000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2001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1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</TotalTime>
  <Words>56</Words>
  <Application>Microsoft Office PowerPoint</Application>
  <PresentationFormat>画面に合わせる (4:3)</PresentationFormat>
  <Paragraphs>1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5" baseType="lpstr">
      <vt:lpstr>Arial</vt:lpstr>
      <vt:lpstr>Symbol</vt:lpstr>
      <vt:lpstr>Office ​​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chika</dc:creator>
  <cp:lastModifiedBy>Midori IKEZAKI</cp:lastModifiedBy>
  <cp:revision>22</cp:revision>
  <cp:lastPrinted>2018-01-18T04:25:13Z</cp:lastPrinted>
  <dcterms:created xsi:type="dcterms:W3CDTF">2016-04-05T01:33:39Z</dcterms:created>
  <dcterms:modified xsi:type="dcterms:W3CDTF">2025-10-20T00:28:45Z</dcterms:modified>
</cp:coreProperties>
</file>